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3"/>
  </p:notesMasterIdLst>
  <p:sldIdLst>
    <p:sldId id="272" r:id="rId5"/>
    <p:sldId id="271" r:id="rId6"/>
    <p:sldId id="259" r:id="rId7"/>
    <p:sldId id="263" r:id="rId8"/>
    <p:sldId id="265" r:id="rId9"/>
    <p:sldId id="264" r:id="rId10"/>
    <p:sldId id="268" r:id="rId11"/>
    <p:sldId id="270" r:id="rId1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398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ams, James (PG/R - School of Vet Med.)" initials="AJ(-SoVM" lastIdx="2" clrIdx="0">
    <p:extLst>
      <p:ext uri="{19B8F6BF-5375-455C-9EA6-DF929625EA0E}">
        <p15:presenceInfo xmlns:p15="http://schemas.microsoft.com/office/powerpoint/2012/main" userId="S::ja01329@surrey.ac.uk::be8f4bdf-2b4c-429b-9d3d-336e77064b9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23"/>
    <p:restoredTop sz="86393"/>
  </p:normalViewPr>
  <p:slideViewPr>
    <p:cSldViewPr snapToGrid="0" snapToObjects="1">
      <p:cViewPr varScale="1">
        <p:scale>
          <a:sx n="142" d="100"/>
          <a:sy n="142" d="100"/>
        </p:scale>
        <p:origin x="2484" y="88"/>
      </p:cViewPr>
      <p:guideLst>
        <p:guide orient="horz" pos="1003"/>
        <p:guide pos="39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B8AEFF-C9E2-E546-95B4-D1070E7B4E97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663848-DD58-BC47-B7FA-77BEB43E6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765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317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923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04603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85083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3624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03394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63848-DD58-BC47-B7FA-77BEB43E6B4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8514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5019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66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369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707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767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0071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700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7112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6685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0535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632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4E0E3-FCD5-144C-9977-A6DB50D040BD}" type="datetimeFigureOut">
              <a:rPr lang="en-GB" smtClean="0"/>
              <a:t>1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EEC38-C362-6348-B64E-59C6C58DE5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686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7" Type="http://schemas.openxmlformats.org/officeDocument/2006/relationships/image" Target="../media/image1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7" Type="http://schemas.openxmlformats.org/officeDocument/2006/relationships/image" Target="../media/image1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4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24B0D6C-3320-4D44-84A7-2D6D6893318A}"/>
              </a:ext>
            </a:extLst>
          </p:cNvPr>
          <p:cNvSpPr txBox="1"/>
          <p:nvPr/>
        </p:nvSpPr>
        <p:spPr>
          <a:xfrm>
            <a:off x="393990" y="6029528"/>
            <a:ext cx="8578634" cy="589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1: Study schematic.</a:t>
            </a:r>
          </a:p>
          <a:p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33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38CEC3-DDA7-B047-9E82-A81F620A00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738" y="1676785"/>
            <a:ext cx="9458325" cy="3400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5397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C3A9118-47C8-7B41-96B9-8215C51EF899}"/>
              </a:ext>
            </a:extLst>
          </p:cNvPr>
          <p:cNvGrpSpPr/>
          <p:nvPr/>
        </p:nvGrpSpPr>
        <p:grpSpPr>
          <a:xfrm>
            <a:off x="787038" y="698844"/>
            <a:ext cx="4607922" cy="2565564"/>
            <a:chOff x="787038" y="698844"/>
            <a:chExt cx="7583640" cy="394349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0FAAE90-DBC2-D84F-A682-FBDBB728C4A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87038" y="698844"/>
              <a:ext cx="7583640" cy="3943494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0CF30DE-C3BE-5143-BBC4-67C9EE17B928}"/>
                </a:ext>
              </a:extLst>
            </p:cNvPr>
            <p:cNvSpPr/>
            <p:nvPr/>
          </p:nvSpPr>
          <p:spPr>
            <a:xfrm>
              <a:off x="3246120" y="813816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C3686E6-046A-9146-9A5E-A19487D98775}"/>
                </a:ext>
              </a:extLst>
            </p:cNvPr>
            <p:cNvSpPr/>
            <p:nvPr/>
          </p:nvSpPr>
          <p:spPr>
            <a:xfrm>
              <a:off x="1972964" y="2874529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FD9D3E8-CC8D-2F46-AC5A-6D9B86F628A4}"/>
                </a:ext>
              </a:extLst>
            </p:cNvPr>
            <p:cNvSpPr/>
            <p:nvPr/>
          </p:nvSpPr>
          <p:spPr>
            <a:xfrm>
              <a:off x="5857745" y="2195103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AF2F073-3F9C-3E4A-A310-0770D3D1D8A6}"/>
                </a:ext>
              </a:extLst>
            </p:cNvPr>
            <p:cNvSpPr/>
            <p:nvPr/>
          </p:nvSpPr>
          <p:spPr>
            <a:xfrm>
              <a:off x="6240935" y="1209230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458D656-B53F-1B4A-91BC-2E9C35EB852A}"/>
                </a:ext>
              </a:extLst>
            </p:cNvPr>
            <p:cNvSpPr/>
            <p:nvPr/>
          </p:nvSpPr>
          <p:spPr>
            <a:xfrm>
              <a:off x="6857337" y="807632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14A14FA-1EE9-7141-9147-DB2938F1F970}"/>
                </a:ext>
              </a:extLst>
            </p:cNvPr>
            <p:cNvSpPr/>
            <p:nvPr/>
          </p:nvSpPr>
          <p:spPr>
            <a:xfrm>
              <a:off x="6473047" y="1437373"/>
              <a:ext cx="539496" cy="4754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CF154AD5-7F28-D041-B208-3D010B26B07C}"/>
              </a:ext>
            </a:extLst>
          </p:cNvPr>
          <p:cNvSpPr txBox="1"/>
          <p:nvPr/>
        </p:nvSpPr>
        <p:spPr>
          <a:xfrm>
            <a:off x="551153" y="4772228"/>
            <a:ext cx="8578634" cy="2113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2: RP-HPLC analysis of HELMs from Bv277.</a:t>
            </a:r>
          </a:p>
          <a:p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: Active SEC fraction from Bv277 were examined by RP-HPLC. Loading was normalized according to volume of initial culture supernatant. Positions of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hlorotetain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C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turin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I), fengycins (F) and surfactins (S) are shown. All components showed some degree of inhibitory activity to CD630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dentity of compounds was indicated by MALDI-TOF analysis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: Activity is enhanced when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lipopep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e combined. Individual fractions from RP-HPLC analysis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were combined, evaporated and resuspended in dH</a:t>
            </a:r>
            <a:r>
              <a:rPr lang="en-GB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 and tested for activity to CD630 using a microdilution assay revealing an activity of 1:640. Individual fractions showed much less activity (1:7-1:320) and the mathematical sum of positive activities was half of the combined activity. ‘Initial’ is the activity of the SEC fraction used for RP-HPLC. The experiment was performed independently three-times. Error bars represent standard deviation. Significance calculated using an unpaired t-test. ****,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&lt; 0.0001. The identity of individual fractions was confirmed by MALDI-TOF analysi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33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DFF747A-E5D2-0F41-AC68-E2A882FA7823}"/>
              </a:ext>
            </a:extLst>
          </p:cNvPr>
          <p:cNvSpPr txBox="1"/>
          <p:nvPr/>
        </p:nvSpPr>
        <p:spPr>
          <a:xfrm>
            <a:off x="445278" y="417087"/>
            <a:ext cx="341760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91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5EE712A-68AA-B948-A81D-F33D101D656D}"/>
              </a:ext>
            </a:extLst>
          </p:cNvPr>
          <p:cNvSpPr txBox="1"/>
          <p:nvPr/>
        </p:nvSpPr>
        <p:spPr>
          <a:xfrm>
            <a:off x="6068838" y="417087"/>
            <a:ext cx="341760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9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0941A17-1EE9-3149-88E8-C0C187E3810F}"/>
              </a:ext>
            </a:extLst>
          </p:cNvPr>
          <p:cNvGrpSpPr/>
          <p:nvPr/>
        </p:nvGrpSpPr>
        <p:grpSpPr>
          <a:xfrm>
            <a:off x="6280795" y="924291"/>
            <a:ext cx="1832462" cy="2489200"/>
            <a:chOff x="9824370" y="3660991"/>
            <a:chExt cx="1832462" cy="2489200"/>
          </a:xfrm>
        </p:grpSpPr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032EC37E-D617-5A4D-9D57-3CA877572D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60373" b="35502"/>
            <a:stretch/>
          </p:blipFill>
          <p:spPr>
            <a:xfrm>
              <a:off x="9824370" y="3660991"/>
              <a:ext cx="1217878" cy="160549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929B0BE-18CF-BF42-A221-AC9647BE6F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0494" r="17252"/>
            <a:stretch/>
          </p:blipFill>
          <p:spPr>
            <a:xfrm>
              <a:off x="10358214" y="3660991"/>
              <a:ext cx="1298618" cy="2489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15378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66D40DA-0EE3-0C44-B4D4-2FBF03A14577}"/>
              </a:ext>
            </a:extLst>
          </p:cNvPr>
          <p:cNvSpPr txBox="1"/>
          <p:nvPr/>
        </p:nvSpPr>
        <p:spPr>
          <a:xfrm>
            <a:off x="1625543" y="3873008"/>
            <a:ext cx="6543231" cy="14362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3: RP-HPLC analysis of HELMs from negative </a:t>
            </a:r>
            <a:r>
              <a:rPr lang="en-GB" sz="11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Bacillus</a:t>
            </a:r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 Isolates.</a:t>
            </a:r>
          </a:p>
          <a:p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EC fractions from strains of two ‘inactive’ strains of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Bacillu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pecies were examined by RP-HPLC (orange line). Positions of iturins (I), fengycins (F) and surfactins (S) are shown. Both strains showed no inhibitory activity to CD630. Bv378 is a human-derived strain while PY79 is a prototrophic (Spo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laboratory strain and a lab stock. The RP-HPLC profile of iturins, fengycins an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urfactin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Bv277 (blue line) are shown for comparison.</a:t>
            </a:r>
          </a:p>
          <a:p>
            <a:endParaRPr lang="en-US" sz="1033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0B5C1C0-7397-F946-9B91-90437759B6D9}"/>
              </a:ext>
            </a:extLst>
          </p:cNvPr>
          <p:cNvGrpSpPr/>
          <p:nvPr/>
        </p:nvGrpSpPr>
        <p:grpSpPr>
          <a:xfrm>
            <a:off x="1872476" y="1215733"/>
            <a:ext cx="5832698" cy="1769260"/>
            <a:chOff x="1422610" y="1148113"/>
            <a:chExt cx="6208298" cy="188319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DC5C453-52DD-884D-A980-DFB467C231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30866" y="1364337"/>
              <a:ext cx="2900042" cy="1666969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B755A85-9678-E341-91B2-27F10248E85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22610" y="1362900"/>
              <a:ext cx="2900042" cy="166840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143004-E33B-254E-A933-3996A8F231A4}"/>
                </a:ext>
              </a:extLst>
            </p:cNvPr>
            <p:cNvSpPr txBox="1"/>
            <p:nvPr/>
          </p:nvSpPr>
          <p:spPr>
            <a:xfrm>
              <a:off x="5225009" y="1148113"/>
              <a:ext cx="2034219" cy="26746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33" b="1" i="1" dirty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GB" sz="1033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elezensis</a:t>
              </a:r>
              <a:r>
                <a:rPr lang="en-GB" sz="1033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033" b="1" dirty="0">
                  <a:latin typeface="Arial" panose="020B0604020202020204" pitchFamily="34" charset="0"/>
                  <a:cs typeface="Arial" panose="020B0604020202020204" pitchFamily="34" charset="0"/>
                </a:rPr>
                <a:t>(Bv378)</a:t>
              </a:r>
              <a:r>
                <a:rPr lang="en-GB" sz="1033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C33FBCC-CA99-C149-B2A3-7EF8F9826B5F}"/>
                </a:ext>
              </a:extLst>
            </p:cNvPr>
            <p:cNvSpPr/>
            <p:nvPr/>
          </p:nvSpPr>
          <p:spPr>
            <a:xfrm>
              <a:off x="1422610" y="1314450"/>
              <a:ext cx="1663490" cy="1673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91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FF9FE2A-4AAD-9846-BCAC-39CCAD544079}"/>
                </a:ext>
              </a:extLst>
            </p:cNvPr>
            <p:cNvSpPr/>
            <p:nvPr/>
          </p:nvSpPr>
          <p:spPr>
            <a:xfrm>
              <a:off x="4860965" y="1350654"/>
              <a:ext cx="1663490" cy="1673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9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F936606-2E22-5242-99B7-72F7C94B46DC}"/>
                </a:ext>
              </a:extLst>
            </p:cNvPr>
            <p:cNvSpPr txBox="1"/>
            <p:nvPr/>
          </p:nvSpPr>
          <p:spPr>
            <a:xfrm>
              <a:off x="1889600" y="1148113"/>
              <a:ext cx="2034219" cy="26746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33" b="1" i="1" dirty="0">
                  <a:latin typeface="Arial" panose="020B0604020202020204" pitchFamily="34" charset="0"/>
                  <a:cs typeface="Arial" panose="020B0604020202020204" pitchFamily="34" charset="0"/>
                </a:rPr>
                <a:t>B. subtilis </a:t>
              </a:r>
              <a:r>
                <a:rPr lang="en-GB" sz="1033" b="1" dirty="0">
                  <a:latin typeface="Arial" panose="020B0604020202020204" pitchFamily="34" charset="0"/>
                  <a:cs typeface="Arial" panose="020B0604020202020204" pitchFamily="34" charset="0"/>
                </a:rPr>
                <a:t>(PY79)</a:t>
              </a:r>
              <a:r>
                <a:rPr lang="en-GB" sz="1033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651562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>
            <a:extLst>
              <a:ext uri="{FF2B5EF4-FFF2-40B4-BE49-F238E27FC236}">
                <a16:creationId xmlns:a16="http://schemas.microsoft.com/office/drawing/2014/main" id="{88641F14-C911-374A-AC52-B477DAB0E1BF}"/>
              </a:ext>
            </a:extLst>
          </p:cNvPr>
          <p:cNvSpPr/>
          <p:nvPr/>
        </p:nvSpPr>
        <p:spPr>
          <a:xfrm>
            <a:off x="173621" y="4533884"/>
            <a:ext cx="9421694" cy="2596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4: Construction of a Bv277</a:t>
            </a:r>
            <a:r>
              <a:rPr lang="en-US" sz="11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srfAA 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mutant (HELM</a:t>
            </a:r>
            <a:r>
              <a:rPr lang="en-US" sz="1100" b="1" u="sng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 2 kbp DNA segment internal to cistron A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f the surfactin A operon was cloned into pSGMU2, a plasmid that can replicate autonomously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E. coli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carrying a gene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a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encoding chloramphenicol resistance (C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The resulting plasmid was introduced into protoplasts of Bv277 with selection for C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Recombinants arise from a single (Campbell-type) recombinational crossover between homologous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NA carried on the vector and the chromosome resulting in a mutant disrupted in the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istron and unable to produce surfactin. The table shows the phenotype of the Bv277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utant; biosurfactant activity (the diameter (mm) of oil dispersion), failure to inhibit growth of CD630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sing a microdilution assay, biofilm formation and lastly, failure of the strain to protect against CD630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lonizatio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NA was extracted from BHIB cultures of Bv277 and a Bv277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utant. cDNA was made using the Qiage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RT Easy First Strand Kit (Cat No. 33042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PCR primers annealing to the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istron (F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GCTCTGATCACTTATCTCTAC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 R,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GAATTTTCATCAGATCCTTCAT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were used for amplification. An amplicon of the correct size (200 bases) was apparent in 3h, 6h and 9h (weak) cultures of the wild type strain but absent in the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fA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utant.</a:t>
            </a: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C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RP-HPLC profile of total methanol extracts from Bv277 (HELM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the BV277 </a:t>
            </a:r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utant (HELM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Bacterial cell pellets (~1x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FU) were extracted in 100% methanol and fractionated using C-18 SPE cartridges to remove polar components prior to separation using RP-HPLC.</a:t>
            </a:r>
          </a:p>
          <a:p>
            <a:pPr algn="just"/>
            <a:endParaRPr lang="en-GB" sz="94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EA69EF4-2733-A249-B8EB-C057FBB162FE}"/>
              </a:ext>
            </a:extLst>
          </p:cNvPr>
          <p:cNvSpPr txBox="1"/>
          <p:nvPr/>
        </p:nvSpPr>
        <p:spPr>
          <a:xfrm>
            <a:off x="617146" y="146416"/>
            <a:ext cx="341760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91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1896B2-EBBA-C54B-B947-F9C2D86DE023}"/>
              </a:ext>
            </a:extLst>
          </p:cNvPr>
          <p:cNvSpPr txBox="1"/>
          <p:nvPr/>
        </p:nvSpPr>
        <p:spPr>
          <a:xfrm>
            <a:off x="5251687" y="146416"/>
            <a:ext cx="341760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9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113C41-790E-DF49-9790-B0F00876CADE}"/>
              </a:ext>
            </a:extLst>
          </p:cNvPr>
          <p:cNvSpPr txBox="1"/>
          <p:nvPr/>
        </p:nvSpPr>
        <p:spPr>
          <a:xfrm>
            <a:off x="5251687" y="2164639"/>
            <a:ext cx="341760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91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6E12FB1-C1F2-B04C-A17B-8CB506DFA7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1293" y="319911"/>
            <a:ext cx="3822074" cy="2318762"/>
          </a:xfrm>
          <a:prstGeom prst="rect">
            <a:avLst/>
          </a:prstGeom>
        </p:spPr>
      </p:pic>
      <p:graphicFrame>
        <p:nvGraphicFramePr>
          <p:cNvPr id="31" name="Table 30">
            <a:extLst>
              <a:ext uri="{FF2B5EF4-FFF2-40B4-BE49-F238E27FC236}">
                <a16:creationId xmlns:a16="http://schemas.microsoft.com/office/drawing/2014/main" id="{18513830-46CC-4D42-8303-AAD2BEC8D2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0659998"/>
              </p:ext>
            </p:extLst>
          </p:nvPr>
        </p:nvGraphicFramePr>
        <p:xfrm>
          <a:off x="849908" y="2757991"/>
          <a:ext cx="4188212" cy="13951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33704">
                  <a:extLst>
                    <a:ext uri="{9D8B030D-6E8A-4147-A177-3AD203B41FA5}">
                      <a16:colId xmlns:a16="http://schemas.microsoft.com/office/drawing/2014/main" val="1958098759"/>
                    </a:ext>
                  </a:extLst>
                </a:gridCol>
                <a:gridCol w="1230273">
                  <a:extLst>
                    <a:ext uri="{9D8B030D-6E8A-4147-A177-3AD203B41FA5}">
                      <a16:colId xmlns:a16="http://schemas.microsoft.com/office/drawing/2014/main" val="2224796756"/>
                    </a:ext>
                  </a:extLst>
                </a:gridCol>
                <a:gridCol w="1124235">
                  <a:extLst>
                    <a:ext uri="{9D8B030D-6E8A-4147-A177-3AD203B41FA5}">
                      <a16:colId xmlns:a16="http://schemas.microsoft.com/office/drawing/2014/main" val="2139362620"/>
                    </a:ext>
                  </a:extLst>
                </a:gridCol>
              </a:tblGrid>
              <a:tr h="22780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ribute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M- (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fAA</a:t>
                      </a:r>
                      <a:r>
                        <a:rPr lang="en-US" sz="8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M+ (Bv277)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1458940731"/>
                  </a:ext>
                </a:extLst>
              </a:tr>
              <a:tr h="21477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iotic</a:t>
                      </a:r>
                      <a:r>
                        <a:rPr lang="en-US" sz="800" baseline="30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8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</a:t>
                      </a:r>
                      <a:r>
                        <a:rPr lang="en-US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</a:t>
                      </a:r>
                      <a:r>
                        <a:rPr lang="en-US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3270627156"/>
                  </a:ext>
                </a:extLst>
              </a:tr>
              <a:tr h="23522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urfactant activity </a:t>
                      </a:r>
                      <a:endParaRPr lang="en-US" sz="8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(&lt;5mm)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+ (20mm)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4090962936"/>
                  </a:ext>
                </a:extLst>
              </a:tr>
              <a:tr h="220906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vitro 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 of CD630 </a:t>
                      </a:r>
                      <a:endParaRPr lang="en-US" sz="8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(0)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(1:160)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3266172982"/>
                  </a:ext>
                </a:extLst>
              </a:tr>
              <a:tr h="214770"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films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+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2037398811"/>
                  </a:ext>
                </a:extLst>
              </a:tr>
              <a:tr h="281630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vivo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ction</a:t>
                      </a:r>
                      <a:endParaRPr lang="en-US" sz="8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5908" marR="85908" marT="42954" marB="4295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+</a:t>
                      </a:r>
                    </a:p>
                  </a:txBody>
                  <a:tcPr marL="85908" marR="85908" marT="42954" marB="42954"/>
                </a:tc>
                <a:extLst>
                  <a:ext uri="{0D108BD9-81ED-4DB2-BD59-A6C34878D82A}">
                    <a16:rowId xmlns:a16="http://schemas.microsoft.com/office/drawing/2014/main" val="1254019128"/>
                  </a:ext>
                </a:extLst>
              </a:tr>
            </a:tbl>
          </a:graphicData>
        </a:graphic>
      </p:graphicFrame>
      <p:grpSp>
        <p:nvGrpSpPr>
          <p:cNvPr id="32" name="Group 31">
            <a:extLst>
              <a:ext uri="{FF2B5EF4-FFF2-40B4-BE49-F238E27FC236}">
                <a16:creationId xmlns:a16="http://schemas.microsoft.com/office/drawing/2014/main" id="{486127EC-45CF-C44D-837D-18E47A55008F}"/>
              </a:ext>
            </a:extLst>
          </p:cNvPr>
          <p:cNvGrpSpPr/>
          <p:nvPr/>
        </p:nvGrpSpPr>
        <p:grpSpPr>
          <a:xfrm>
            <a:off x="5749120" y="1919399"/>
            <a:ext cx="3463763" cy="2111708"/>
            <a:chOff x="0" y="0"/>
            <a:chExt cx="4012971" cy="3761740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CFECD16D-EBC3-1A4D-97EB-1A7487E200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7640"/>
            <a:stretch/>
          </p:blipFill>
          <p:spPr bwMode="auto">
            <a:xfrm>
              <a:off x="0" y="0"/>
              <a:ext cx="4012971" cy="3761740"/>
            </a:xfrm>
            <a:prstGeom prst="rect">
              <a:avLst/>
            </a:prstGeom>
            <a:noFill/>
          </p:spPr>
        </p:pic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A8799327-0D0A-E745-A393-B23E03F5EA02}"/>
                </a:ext>
              </a:extLst>
            </p:cNvPr>
            <p:cNvCxnSpPr/>
            <p:nvPr/>
          </p:nvCxnSpPr>
          <p:spPr>
            <a:xfrm flipV="1">
              <a:off x="1219200" y="3238500"/>
              <a:ext cx="1041400" cy="6350"/>
            </a:xfrm>
            <a:prstGeom prst="line">
              <a:avLst/>
            </a:prstGeom>
            <a:ln w="825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034FB5C-55FC-FD46-8E0D-0FF2901668DB}"/>
                </a:ext>
              </a:extLst>
            </p:cNvPr>
            <p:cNvCxnSpPr/>
            <p:nvPr/>
          </p:nvCxnSpPr>
          <p:spPr>
            <a:xfrm flipV="1">
              <a:off x="3149600" y="3257550"/>
              <a:ext cx="495300" cy="0"/>
            </a:xfrm>
            <a:prstGeom prst="line">
              <a:avLst/>
            </a:prstGeom>
            <a:ln w="825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2BB1FCDC-BA42-D644-B757-8036D6C1D6F2}"/>
                </a:ext>
              </a:extLst>
            </p:cNvPr>
            <p:cNvCxnSpPr/>
            <p:nvPr/>
          </p:nvCxnSpPr>
          <p:spPr>
            <a:xfrm flipV="1">
              <a:off x="2844800" y="3384550"/>
              <a:ext cx="533400" cy="0"/>
            </a:xfrm>
            <a:prstGeom prst="line">
              <a:avLst/>
            </a:prstGeom>
            <a:ln w="825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7" name="Picture 36">
            <a:extLst>
              <a:ext uri="{FF2B5EF4-FFF2-40B4-BE49-F238E27FC236}">
                <a16:creationId xmlns:a16="http://schemas.microsoft.com/office/drawing/2014/main" id="{D6C7AFFE-9C86-D04B-A5FC-E0326E4321C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3937" t="8452" r="68644" b="77499"/>
          <a:stretch/>
        </p:blipFill>
        <p:spPr>
          <a:xfrm>
            <a:off x="6111494" y="2312961"/>
            <a:ext cx="369603" cy="40956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5E07E622-20F5-F244-8241-C9FF0B40235C}"/>
              </a:ext>
            </a:extLst>
          </p:cNvPr>
          <p:cNvSpPr txBox="1"/>
          <p:nvPr/>
        </p:nvSpPr>
        <p:spPr>
          <a:xfrm>
            <a:off x="6397395" y="2506705"/>
            <a:ext cx="1989978" cy="251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HELM</a:t>
            </a:r>
            <a:r>
              <a:rPr lang="en-GB" sz="103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 (Bv277) </a:t>
            </a:r>
            <a:endParaRPr lang="en-US" sz="10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CBD4279-BFB1-6F4D-80D0-5DF4D4F2EC09}"/>
              </a:ext>
            </a:extLst>
          </p:cNvPr>
          <p:cNvSpPr txBox="1"/>
          <p:nvPr/>
        </p:nvSpPr>
        <p:spPr>
          <a:xfrm>
            <a:off x="6397395" y="2312958"/>
            <a:ext cx="1807189" cy="251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HELM</a:t>
            </a:r>
            <a:r>
              <a:rPr lang="en-GB" sz="1033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33" i="1" dirty="0" err="1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0D402A5-047A-0A40-9D4A-42D2ED0A5E7F}"/>
              </a:ext>
            </a:extLst>
          </p:cNvPr>
          <p:cNvSpPr txBox="1"/>
          <p:nvPr/>
        </p:nvSpPr>
        <p:spPr>
          <a:xfrm>
            <a:off x="6214687" y="4276429"/>
            <a:ext cx="930105" cy="352661"/>
          </a:xfrm>
          <a:prstGeom prst="rect">
            <a:avLst/>
          </a:prstGeom>
          <a:noFill/>
          <a:ln w="22225">
            <a:solidFill>
              <a:srgbClr val="00B14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46" b="1" dirty="0">
                <a:latin typeface="Arial" panose="020B0604020202020204" pitchFamily="34" charset="0"/>
                <a:cs typeface="Arial" panose="020B0604020202020204" pitchFamily="34" charset="0"/>
              </a:rPr>
              <a:t>Iturins </a:t>
            </a:r>
          </a:p>
          <a:p>
            <a:pPr algn="ctr"/>
            <a:r>
              <a:rPr lang="en-GB" sz="846" dirty="0">
                <a:latin typeface="Arial" panose="020B0604020202020204" pitchFamily="34" charset="0"/>
                <a:cs typeface="Arial" panose="020B0604020202020204" pitchFamily="34" charset="0"/>
              </a:rPr>
              <a:t>C12-C16</a:t>
            </a:r>
            <a:endParaRPr lang="en-US" sz="8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D73CAB3-E3A3-F141-A968-57EDEB78A62F}"/>
              </a:ext>
            </a:extLst>
          </p:cNvPr>
          <p:cNvSpPr txBox="1"/>
          <p:nvPr/>
        </p:nvSpPr>
        <p:spPr>
          <a:xfrm>
            <a:off x="8204586" y="4276429"/>
            <a:ext cx="930105" cy="352661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46" b="1" dirty="0">
                <a:latin typeface="Arial" panose="020B0604020202020204" pitchFamily="34" charset="0"/>
                <a:cs typeface="Arial" panose="020B0604020202020204" pitchFamily="34" charset="0"/>
              </a:rPr>
              <a:t>Surfactins </a:t>
            </a:r>
          </a:p>
          <a:p>
            <a:pPr algn="ctr"/>
            <a:r>
              <a:rPr lang="en-GB" sz="846" dirty="0">
                <a:latin typeface="Arial" panose="020B0604020202020204" pitchFamily="34" charset="0"/>
                <a:cs typeface="Arial" panose="020B0604020202020204" pitchFamily="34" charset="0"/>
              </a:rPr>
              <a:t>C13-C15</a:t>
            </a:r>
            <a:endParaRPr lang="en-US" sz="84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6172F4D-91BC-F54E-92B0-9C1D5CE08A38}"/>
              </a:ext>
            </a:extLst>
          </p:cNvPr>
          <p:cNvSpPr txBox="1"/>
          <p:nvPr/>
        </p:nvSpPr>
        <p:spPr>
          <a:xfrm>
            <a:off x="7209637" y="4276429"/>
            <a:ext cx="930105" cy="352661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46" b="1" dirty="0">
                <a:latin typeface="Arial" panose="020B0604020202020204" pitchFamily="34" charset="0"/>
                <a:cs typeface="Arial" panose="020B0604020202020204" pitchFamily="34" charset="0"/>
              </a:rPr>
              <a:t>Fengycins </a:t>
            </a:r>
            <a:endParaRPr lang="en-GB" sz="846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846" dirty="0">
                <a:latin typeface="Arial" panose="020B0604020202020204" pitchFamily="34" charset="0"/>
                <a:cs typeface="Arial" panose="020B0604020202020204" pitchFamily="34" charset="0"/>
              </a:rPr>
              <a:t>C15-C18</a:t>
            </a:r>
            <a:endParaRPr lang="en-US" sz="84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D971551-72B3-374D-8556-80A2A557D8F8}"/>
              </a:ext>
            </a:extLst>
          </p:cNvPr>
          <p:cNvSpPr txBox="1"/>
          <p:nvPr/>
        </p:nvSpPr>
        <p:spPr>
          <a:xfrm>
            <a:off x="7326402" y="4030646"/>
            <a:ext cx="1551670" cy="251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33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  <a:endParaRPr lang="en-US" sz="10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2770C7F-124E-E54F-8A73-F6984EFBC09A}"/>
              </a:ext>
            </a:extLst>
          </p:cNvPr>
          <p:cNvSpPr txBox="1"/>
          <p:nvPr/>
        </p:nvSpPr>
        <p:spPr>
          <a:xfrm rot="16200000">
            <a:off x="5401610" y="2728567"/>
            <a:ext cx="695012" cy="251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33" dirty="0"/>
              <a:t>A</a:t>
            </a:r>
            <a:r>
              <a:rPr lang="en-GB" sz="1033" baseline="-25000" dirty="0"/>
              <a:t>220nm</a:t>
            </a:r>
            <a:endParaRPr lang="en-US" sz="1033" dirty="0"/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7F93CB45-79A4-1749-9E7C-538816B01B03}"/>
              </a:ext>
            </a:extLst>
          </p:cNvPr>
          <p:cNvGrpSpPr/>
          <p:nvPr/>
        </p:nvGrpSpPr>
        <p:grpSpPr>
          <a:xfrm>
            <a:off x="5749118" y="206027"/>
            <a:ext cx="3551220" cy="1579767"/>
            <a:chOff x="5984251" y="684931"/>
            <a:chExt cx="3551220" cy="1579767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E2C7799B-ECDC-1545-BFC4-3626C5D437B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984251" y="723492"/>
              <a:ext cx="3551220" cy="1541206"/>
            </a:xfrm>
            <a:prstGeom prst="rect">
              <a:avLst/>
            </a:prstGeom>
          </p:spPr>
        </p:pic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6CC8A590-B7F5-1D48-A4D4-16BE9B08A0AA}"/>
                </a:ext>
              </a:extLst>
            </p:cNvPr>
            <p:cNvSpPr/>
            <p:nvPr/>
          </p:nvSpPr>
          <p:spPr>
            <a:xfrm>
              <a:off x="8132249" y="684931"/>
              <a:ext cx="570553" cy="1738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82B7471-DBC0-044B-89DE-43ADBD050698}"/>
                </a:ext>
              </a:extLst>
            </p:cNvPr>
            <p:cNvSpPr txBox="1"/>
            <p:nvPr/>
          </p:nvSpPr>
          <p:spPr>
            <a:xfrm>
              <a:off x="8281777" y="703005"/>
              <a:ext cx="5319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/>
                <a:t>BV277</a:t>
              </a:r>
              <a:endParaRPr lang="en-GB" sz="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3031250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CC2008D-0138-5E45-BCC1-634F696C8A28}"/>
              </a:ext>
            </a:extLst>
          </p:cNvPr>
          <p:cNvSpPr/>
          <p:nvPr/>
        </p:nvSpPr>
        <p:spPr>
          <a:xfrm>
            <a:off x="432063" y="4501942"/>
            <a:ext cx="9041874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5: RP-HPLC Analysis of HELMs Present in the Small Intestine</a:t>
            </a:r>
          </a:p>
          <a:p>
            <a:pPr algn="just"/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RP-HPLC elution profiles of methanol-extracted, pooled, SI contents taken from groups (n=3) of clindamycin treated (30 mg/kg) and naïve mice. Identified lipopeptides are shown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olor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bars) and were confirmed using MALDI-TOF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lso shown is the expected elution profile of secondary bile acids (grey bar).</a:t>
            </a:r>
          </a:p>
          <a:p>
            <a:pPr algn="just"/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3E985378-D026-9044-90CA-381E097D3B59}"/>
              </a:ext>
            </a:extLst>
          </p:cNvPr>
          <p:cNvGrpSpPr/>
          <p:nvPr/>
        </p:nvGrpSpPr>
        <p:grpSpPr>
          <a:xfrm>
            <a:off x="2377142" y="1285104"/>
            <a:ext cx="4516167" cy="2973588"/>
            <a:chOff x="594062" y="1202808"/>
            <a:chExt cx="4516167" cy="2973588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8B15156-5A2C-B84C-8350-EC8B27FED61A}"/>
                </a:ext>
              </a:extLst>
            </p:cNvPr>
            <p:cNvSpPr txBox="1"/>
            <p:nvPr/>
          </p:nvSpPr>
          <p:spPr>
            <a:xfrm>
              <a:off x="594062" y="1202808"/>
              <a:ext cx="359394" cy="381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79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3AF1F1B-CBA8-894A-8C02-613A95723F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0737" y="1584323"/>
              <a:ext cx="4429492" cy="259207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717922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7A62CED-0453-6940-9139-C76EF4BC35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8846" y="1102858"/>
            <a:ext cx="7088307" cy="27972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29396F5-2057-014E-88A4-60F21C25B3EC}"/>
              </a:ext>
            </a:extLst>
          </p:cNvPr>
          <p:cNvSpPr txBox="1"/>
          <p:nvPr/>
        </p:nvSpPr>
        <p:spPr>
          <a:xfrm>
            <a:off x="452438" y="4091567"/>
            <a:ext cx="9140552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6: </a:t>
            </a:r>
            <a:r>
              <a:rPr lang="en-GB" sz="11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C. difficile </a:t>
            </a:r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germinates in the presence or absence of clindamycin within the GI-tract</a:t>
            </a:r>
          </a:p>
          <a:p>
            <a:pPr algn="just"/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ce housed in groups (n=4) were dosed (i.g.) with clindamycin or left untreated. 24h post-dosing with clindamycin, mice from the treated and non-treated cages were culled and SI contents removed. Processed intestinal contents were added to CD630 spores to a final concentration of 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FU/ml and incubated at 37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 (anaerobic). Total counts and heat-resistant counts (6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, 20 min) at different time points were plated. The data shows that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ex viv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the counts (CFU) of CD630 declined (due to spore germination) after 5h in the presence of SI-extracts regardless of prior antibiotic treatment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experiment was performed independently three times. Error bars represent standard deviation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3 mice were dosed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.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) with 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630 spores and a single mouse culled at each time point. The stomach (ST), SI and large intestine (LI) were removed, added to pre-reduced PBS, homogenised, serially diluted and plated on BHISS for enumeration of total CD630 counts and heat-resistant (6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, 20min.) spore CD630 counts. The data shows that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CD630 does not germinate in the stomach but in the SI and LI there is almost complete germination of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. difficil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pores ± clindamycin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experiment was performed independently two times. Error bars represent standard deviation. </a:t>
            </a:r>
            <a:endParaRPr lang="en-US" sz="11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20C85D4-43D0-8641-9E67-A51CC20FEF3E}"/>
              </a:ext>
            </a:extLst>
          </p:cNvPr>
          <p:cNvSpPr txBox="1"/>
          <p:nvPr/>
        </p:nvSpPr>
        <p:spPr>
          <a:xfrm>
            <a:off x="1339502" y="542041"/>
            <a:ext cx="394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FA22F9-0D18-AF42-953A-42FEBE85020F}"/>
              </a:ext>
            </a:extLst>
          </p:cNvPr>
          <p:cNvSpPr txBox="1"/>
          <p:nvPr/>
        </p:nvSpPr>
        <p:spPr>
          <a:xfrm>
            <a:off x="4952999" y="542041"/>
            <a:ext cx="33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061F881-35DE-3A42-B382-B55C4ABC8EBC}"/>
              </a:ext>
            </a:extLst>
          </p:cNvPr>
          <p:cNvSpPr/>
          <p:nvPr/>
        </p:nvSpPr>
        <p:spPr>
          <a:xfrm>
            <a:off x="5938804" y="978328"/>
            <a:ext cx="1650716" cy="4510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40D6D6F-53A6-1A49-8D0B-EF8E73218931}"/>
              </a:ext>
            </a:extLst>
          </p:cNvPr>
          <p:cNvSpPr/>
          <p:nvPr/>
        </p:nvSpPr>
        <p:spPr>
          <a:xfrm>
            <a:off x="2214148" y="1047994"/>
            <a:ext cx="1650716" cy="4510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0D11279-5A19-C84D-9A30-81302923DE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054" r="26306" b="88419"/>
          <a:stretch/>
        </p:blipFill>
        <p:spPr>
          <a:xfrm>
            <a:off x="5721746" y="1220860"/>
            <a:ext cx="1463040" cy="32393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A97875-9572-D947-95D3-3F6249FEC4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6894" b="88867"/>
          <a:stretch/>
        </p:blipFill>
        <p:spPr>
          <a:xfrm>
            <a:off x="1861951" y="1208496"/>
            <a:ext cx="1637820" cy="311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93693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92A844BE-28BE-A94E-84A7-60A29688AABF}"/>
              </a:ext>
            </a:extLst>
          </p:cNvPr>
          <p:cNvSpPr txBox="1"/>
          <p:nvPr/>
        </p:nvSpPr>
        <p:spPr>
          <a:xfrm>
            <a:off x="97662" y="4903321"/>
            <a:ext cx="9440196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7: Studies in Mice and Golden Syrian hamster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: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biota depletion model. Mice (n=6/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treated with an antibiotic cocktail for 7-days, followed by a wash out period of 2-days before being challenged with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D630 spores. Mice were dosed three times daily with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FU spores of HELM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v277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L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rfAA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PBS (naïve) during the two washout days and on the day of challenge. 24h post-challenge ceca was removed for analysis of toxin A. Corresponding levels of ethanol resistant spore counts are shown in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6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olonization rate in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6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 and 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olden Syrian hamsters were administered clindamycin and 13h later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sed 3-times/day (6h intervals) orally (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.g.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ith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~2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FU/dose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HELM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v277), HELM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v378)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the cell free supernatant of HELM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2 ml/dose) until study end. 72h post-clindamycin treatment animals were challenged with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ores of CD630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sis of toxin levels present in ceca are shown (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ethanol-resistant spore counts can be seen in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anel 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Corresponding survival is shown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6C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B59D1AE-546A-A440-9E7B-CFF5B563F869}"/>
              </a:ext>
            </a:extLst>
          </p:cNvPr>
          <p:cNvSpPr txBox="1"/>
          <p:nvPr/>
        </p:nvSpPr>
        <p:spPr>
          <a:xfrm>
            <a:off x="2226287" y="5688609"/>
            <a:ext cx="184731" cy="352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691" dirty="0"/>
          </a:p>
        </p:txBody>
      </p:sp>
      <p:pic>
        <p:nvPicPr>
          <p:cNvPr id="120" name="Picture 119">
            <a:extLst>
              <a:ext uri="{FF2B5EF4-FFF2-40B4-BE49-F238E27FC236}">
                <a16:creationId xmlns:a16="http://schemas.microsoft.com/office/drawing/2014/main" id="{6AA3AD93-6DEF-2F4A-9BDA-18BF4E247F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4165" y="1523327"/>
            <a:ext cx="2357064" cy="1669096"/>
          </a:xfrm>
          <a:prstGeom prst="rect">
            <a:avLst/>
          </a:prstGeom>
        </p:spPr>
      </p:pic>
      <p:sp>
        <p:nvSpPr>
          <p:cNvPr id="139" name="TextBox 138">
            <a:extLst>
              <a:ext uri="{FF2B5EF4-FFF2-40B4-BE49-F238E27FC236}">
                <a16:creationId xmlns:a16="http://schemas.microsoft.com/office/drawing/2014/main" id="{C40109AF-C0E5-584F-9577-9FF324147536}"/>
              </a:ext>
            </a:extLst>
          </p:cNvPr>
          <p:cNvSpPr txBox="1"/>
          <p:nvPr/>
        </p:nvSpPr>
        <p:spPr>
          <a:xfrm>
            <a:off x="3346540" y="1095709"/>
            <a:ext cx="601614" cy="3815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7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55B9F01-B609-E14C-B26A-86B68C1AAFAC}"/>
              </a:ext>
            </a:extLst>
          </p:cNvPr>
          <p:cNvSpPr txBox="1"/>
          <p:nvPr/>
        </p:nvSpPr>
        <p:spPr>
          <a:xfrm rot="18180000">
            <a:off x="7274743" y="3259035"/>
            <a:ext cx="550151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HELM+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B697979-D953-944E-B474-89D72E6325A2}"/>
              </a:ext>
            </a:extLst>
          </p:cNvPr>
          <p:cNvSpPr txBox="1"/>
          <p:nvPr/>
        </p:nvSpPr>
        <p:spPr>
          <a:xfrm rot="18180000">
            <a:off x="7824765" y="3243860"/>
            <a:ext cx="52290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HELM-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B286C2C-BC66-9242-A383-06D2E62373C8}"/>
              </a:ext>
            </a:extLst>
          </p:cNvPr>
          <p:cNvSpPr txBox="1"/>
          <p:nvPr/>
        </p:nvSpPr>
        <p:spPr>
          <a:xfrm rot="18180000">
            <a:off x="8397237" y="3208465"/>
            <a:ext cx="407484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SUP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2977171-648F-9B46-9D0C-E0E1E9A731CE}"/>
              </a:ext>
            </a:extLst>
          </p:cNvPr>
          <p:cNvSpPr txBox="1"/>
          <p:nvPr/>
        </p:nvSpPr>
        <p:spPr>
          <a:xfrm rot="18180000">
            <a:off x="8934148" y="3212284"/>
            <a:ext cx="445956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97F9AE83-F80A-7F48-AE48-5DD048C3BB7B}"/>
              </a:ext>
            </a:extLst>
          </p:cNvPr>
          <p:cNvSpPr txBox="1"/>
          <p:nvPr/>
        </p:nvSpPr>
        <p:spPr>
          <a:xfrm rot="16200000">
            <a:off x="6226319" y="2194512"/>
            <a:ext cx="1293944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CD630 cecum (CFU/g)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F865433-7CF4-0F4B-A3B9-FBA26ACAD994}"/>
              </a:ext>
            </a:extLst>
          </p:cNvPr>
          <p:cNvSpPr txBox="1"/>
          <p:nvPr/>
        </p:nvSpPr>
        <p:spPr>
          <a:xfrm>
            <a:off x="6889381" y="1513616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64682BED-1555-624F-A3F4-6B3FD4992BB3}"/>
              </a:ext>
            </a:extLst>
          </p:cNvPr>
          <p:cNvSpPr txBox="1"/>
          <p:nvPr/>
        </p:nvSpPr>
        <p:spPr>
          <a:xfrm>
            <a:off x="6889717" y="1830805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871A14EE-BA65-0147-ABC9-108332BAF5B8}"/>
              </a:ext>
            </a:extLst>
          </p:cNvPr>
          <p:cNvSpPr txBox="1"/>
          <p:nvPr/>
        </p:nvSpPr>
        <p:spPr>
          <a:xfrm>
            <a:off x="6894311" y="2138756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93BB04BC-716C-D741-9D93-8284A9EF5B28}"/>
              </a:ext>
            </a:extLst>
          </p:cNvPr>
          <p:cNvSpPr txBox="1"/>
          <p:nvPr/>
        </p:nvSpPr>
        <p:spPr>
          <a:xfrm>
            <a:off x="6894647" y="2438183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095019F-2BA8-4B4B-8B2C-601C04EDFAF5}"/>
              </a:ext>
            </a:extLst>
          </p:cNvPr>
          <p:cNvSpPr txBox="1"/>
          <p:nvPr/>
        </p:nvSpPr>
        <p:spPr>
          <a:xfrm>
            <a:off x="6894982" y="2728373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7826638-62F5-554D-B452-ABD9C3F0FF4B}"/>
              </a:ext>
            </a:extLst>
          </p:cNvPr>
          <p:cNvSpPr txBox="1"/>
          <p:nvPr/>
        </p:nvSpPr>
        <p:spPr>
          <a:xfrm>
            <a:off x="6895317" y="3036324"/>
            <a:ext cx="346570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46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D61BBC5-6898-F448-A009-A7D381063F96}"/>
              </a:ext>
            </a:extLst>
          </p:cNvPr>
          <p:cNvSpPr txBox="1"/>
          <p:nvPr/>
        </p:nvSpPr>
        <p:spPr>
          <a:xfrm>
            <a:off x="172225" y="1096991"/>
            <a:ext cx="322098" cy="3815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7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87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98F86547-B3CE-4E46-A9FB-80C8782176D8}"/>
              </a:ext>
            </a:extLst>
          </p:cNvPr>
          <p:cNvGrpSpPr/>
          <p:nvPr/>
        </p:nvGrpSpPr>
        <p:grpSpPr>
          <a:xfrm>
            <a:off x="3575840" y="1220655"/>
            <a:ext cx="2578721" cy="2408879"/>
            <a:chOff x="894881" y="3604057"/>
            <a:chExt cx="2500987" cy="2364210"/>
          </a:xfrm>
        </p:grpSpPr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E67B6162-EB36-884E-8432-8005D2C67D83}"/>
                </a:ext>
              </a:extLst>
            </p:cNvPr>
            <p:cNvSpPr txBox="1"/>
            <p:nvPr/>
          </p:nvSpPr>
          <p:spPr>
            <a:xfrm rot="18180000">
              <a:off x="1731080" y="5546140"/>
              <a:ext cx="399928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SUP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D5AB5AEF-281A-164A-B546-2EC906DE9BDD}"/>
                </a:ext>
              </a:extLst>
            </p:cNvPr>
            <p:cNvSpPr txBox="1"/>
            <p:nvPr/>
          </p:nvSpPr>
          <p:spPr>
            <a:xfrm rot="18180000">
              <a:off x="1952820" y="5546043"/>
              <a:ext cx="437686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50F32D2E-137A-6C44-8C59-E7780302D822}"/>
                </a:ext>
              </a:extLst>
            </p:cNvPr>
            <p:cNvSpPr txBox="1"/>
            <p:nvPr/>
          </p:nvSpPr>
          <p:spPr>
            <a:xfrm rot="18180000">
              <a:off x="1148321" y="5590398"/>
              <a:ext cx="539949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HELM+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D0F0361-D197-FD43-8E6E-03369E15621F}"/>
                </a:ext>
              </a:extLst>
            </p:cNvPr>
            <p:cNvSpPr txBox="1"/>
            <p:nvPr/>
          </p:nvSpPr>
          <p:spPr>
            <a:xfrm rot="18180000">
              <a:off x="1385310" y="5581688"/>
              <a:ext cx="513204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HELM-</a:t>
              </a:r>
            </a:p>
          </p:txBody>
        </p: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F0F65FCF-7B69-A843-BD50-5AEEE45E102A}"/>
                </a:ext>
              </a:extLst>
            </p:cNvPr>
            <p:cNvCxnSpPr>
              <a:cxnSpLocks/>
            </p:cNvCxnSpPr>
            <p:nvPr/>
          </p:nvCxnSpPr>
          <p:spPr>
            <a:xfrm>
              <a:off x="2542196" y="3859973"/>
              <a:ext cx="8045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94F05A4E-AB4F-6841-9CCB-D438CB32D460}"/>
                </a:ext>
              </a:extLst>
            </p:cNvPr>
            <p:cNvSpPr txBox="1"/>
            <p:nvPr/>
          </p:nvSpPr>
          <p:spPr>
            <a:xfrm>
              <a:off x="1569611" y="3604057"/>
              <a:ext cx="577098" cy="2325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40" dirty="0">
                  <a:latin typeface="Arial" panose="020B0604020202020204" pitchFamily="34" charset="0"/>
                  <a:cs typeface="Arial" panose="020B0604020202020204" pitchFamily="34" charset="0"/>
                </a:rPr>
                <a:t>Toxin A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B2195488-4718-884B-B2A0-111F4C266F37}"/>
                </a:ext>
              </a:extLst>
            </p:cNvPr>
            <p:cNvSpPr txBox="1"/>
            <p:nvPr/>
          </p:nvSpPr>
          <p:spPr>
            <a:xfrm>
              <a:off x="2690501" y="3613087"/>
              <a:ext cx="577098" cy="2325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40" dirty="0">
                  <a:latin typeface="Arial" panose="020B0604020202020204" pitchFamily="34" charset="0"/>
                  <a:cs typeface="Arial" panose="020B0604020202020204" pitchFamily="34" charset="0"/>
                </a:rPr>
                <a:t>Toxin B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A2762FE7-5D0D-6F41-8691-69419179804D}"/>
                </a:ext>
              </a:extLst>
            </p:cNvPr>
            <p:cNvSpPr txBox="1"/>
            <p:nvPr/>
          </p:nvSpPr>
          <p:spPr>
            <a:xfrm>
              <a:off x="894881" y="3868399"/>
              <a:ext cx="415411" cy="218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325CBE9C-E8BE-5D4D-9A14-6A6445B51C8D}"/>
                </a:ext>
              </a:extLst>
            </p:cNvPr>
            <p:cNvSpPr txBox="1"/>
            <p:nvPr/>
          </p:nvSpPr>
          <p:spPr>
            <a:xfrm>
              <a:off x="894886" y="4363507"/>
              <a:ext cx="466576" cy="2183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8F7DB469-7725-D542-AA20-AE2CB1B7A244}"/>
                </a:ext>
              </a:extLst>
            </p:cNvPr>
            <p:cNvSpPr txBox="1"/>
            <p:nvPr/>
          </p:nvSpPr>
          <p:spPr>
            <a:xfrm>
              <a:off x="953816" y="4859123"/>
              <a:ext cx="356333" cy="218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DC031983-C79B-0043-81B0-FCDBE7EBD0FD}"/>
                </a:ext>
              </a:extLst>
            </p:cNvPr>
            <p:cNvSpPr txBox="1"/>
            <p:nvPr/>
          </p:nvSpPr>
          <p:spPr>
            <a:xfrm>
              <a:off x="1062662" y="5344992"/>
              <a:ext cx="238177" cy="218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40F8EC57-9BFD-CB47-BDF8-663C0EAB8F66}"/>
                </a:ext>
              </a:extLst>
            </p:cNvPr>
            <p:cNvSpPr txBox="1"/>
            <p:nvPr/>
          </p:nvSpPr>
          <p:spPr>
            <a:xfrm rot="18180000">
              <a:off x="2835883" y="5544434"/>
              <a:ext cx="399928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SUP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63D6621C-7D34-EF4F-A10A-C7E7E3AD425C}"/>
                </a:ext>
              </a:extLst>
            </p:cNvPr>
            <p:cNvSpPr txBox="1"/>
            <p:nvPr/>
          </p:nvSpPr>
          <p:spPr>
            <a:xfrm rot="18180000">
              <a:off x="3069130" y="5548020"/>
              <a:ext cx="437686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F749AEFA-E967-D247-8AFE-9CE32CF51389}"/>
                </a:ext>
              </a:extLst>
            </p:cNvPr>
            <p:cNvSpPr txBox="1"/>
            <p:nvPr/>
          </p:nvSpPr>
          <p:spPr>
            <a:xfrm rot="18180000">
              <a:off x="2262845" y="5589715"/>
              <a:ext cx="539949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HELM+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8AAEA32F-A195-F54A-AC9E-993F687A0E38}"/>
                </a:ext>
              </a:extLst>
            </p:cNvPr>
            <p:cNvSpPr txBox="1"/>
            <p:nvPr/>
          </p:nvSpPr>
          <p:spPr>
            <a:xfrm rot="18180000">
              <a:off x="2546496" y="5576935"/>
              <a:ext cx="513204" cy="215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46" dirty="0">
                  <a:latin typeface="Arial" panose="020B0604020202020204" pitchFamily="34" charset="0"/>
                  <a:cs typeface="Arial" panose="020B0604020202020204" pitchFamily="34" charset="0"/>
                </a:rPr>
                <a:t>HELM-</a:t>
              </a:r>
            </a:p>
          </p:txBody>
        </p:sp>
      </p:grpSp>
      <p:sp>
        <p:nvSpPr>
          <p:cNvPr id="188" name="TextBox 187">
            <a:extLst>
              <a:ext uri="{FF2B5EF4-FFF2-40B4-BE49-F238E27FC236}">
                <a16:creationId xmlns:a16="http://schemas.microsoft.com/office/drawing/2014/main" id="{2BF5F427-E30D-DE4C-B277-6EB38072CB00}"/>
              </a:ext>
            </a:extLst>
          </p:cNvPr>
          <p:cNvSpPr txBox="1"/>
          <p:nvPr/>
        </p:nvSpPr>
        <p:spPr>
          <a:xfrm rot="16200000">
            <a:off x="2906228" y="2258013"/>
            <a:ext cx="1228221" cy="22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46" dirty="0">
                <a:latin typeface="Arial" panose="020B0604020202020204" pitchFamily="34" charset="0"/>
                <a:cs typeface="Arial" panose="020B0604020202020204" pitchFamily="34" charset="0"/>
              </a:rPr>
              <a:t>Cecum Toxins  (ng/g)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980CBB43-5DC8-3948-B46D-FDB759012AFA}"/>
              </a:ext>
            </a:extLst>
          </p:cNvPr>
          <p:cNvCxnSpPr>
            <a:cxnSpLocks/>
          </p:cNvCxnSpPr>
          <p:nvPr/>
        </p:nvCxnSpPr>
        <p:spPr>
          <a:xfrm>
            <a:off x="4118920" y="1484731"/>
            <a:ext cx="8295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0" name="Picture 189">
            <a:extLst>
              <a:ext uri="{FF2B5EF4-FFF2-40B4-BE49-F238E27FC236}">
                <a16:creationId xmlns:a16="http://schemas.microsoft.com/office/drawing/2014/main" id="{68326337-0DAD-0A4E-94DE-A2A91B5CFB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6341" y="1544917"/>
            <a:ext cx="2356433" cy="1612372"/>
          </a:xfrm>
          <a:prstGeom prst="rect">
            <a:avLst/>
          </a:prstGeom>
        </p:spPr>
      </p:pic>
      <p:sp>
        <p:nvSpPr>
          <p:cNvPr id="191" name="TextBox 190">
            <a:extLst>
              <a:ext uri="{FF2B5EF4-FFF2-40B4-BE49-F238E27FC236}">
                <a16:creationId xmlns:a16="http://schemas.microsoft.com/office/drawing/2014/main" id="{4B8753D3-E661-0543-B4AD-40A549B70215}"/>
              </a:ext>
            </a:extLst>
          </p:cNvPr>
          <p:cNvSpPr txBox="1"/>
          <p:nvPr/>
        </p:nvSpPr>
        <p:spPr>
          <a:xfrm>
            <a:off x="6707432" y="1103712"/>
            <a:ext cx="333558" cy="3815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79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3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BDE19A91-3B63-BE40-8985-B4035271CEF5}"/>
              </a:ext>
            </a:extLst>
          </p:cNvPr>
          <p:cNvSpPr txBox="1"/>
          <p:nvPr/>
        </p:nvSpPr>
        <p:spPr>
          <a:xfrm>
            <a:off x="7626729" y="1305611"/>
            <a:ext cx="795132" cy="208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52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75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3F458A64-A80E-A841-9680-0E5F1A28BC17}"/>
              </a:ext>
            </a:extLst>
          </p:cNvPr>
          <p:cNvCxnSpPr>
            <a:cxnSpLocks/>
          </p:cNvCxnSpPr>
          <p:nvPr/>
        </p:nvCxnSpPr>
        <p:spPr>
          <a:xfrm>
            <a:off x="7554141" y="1452183"/>
            <a:ext cx="5410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9A3AF3FA-8778-6F42-8CB9-E750213C311A}"/>
              </a:ext>
            </a:extLst>
          </p:cNvPr>
          <p:cNvCxnSpPr>
            <a:cxnSpLocks/>
          </p:cNvCxnSpPr>
          <p:nvPr/>
        </p:nvCxnSpPr>
        <p:spPr>
          <a:xfrm>
            <a:off x="7557973" y="1453426"/>
            <a:ext cx="0" cy="486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6D83671D-9F7B-D64F-AF82-3585B0E757A6}"/>
              </a:ext>
            </a:extLst>
          </p:cNvPr>
          <p:cNvCxnSpPr>
            <a:cxnSpLocks/>
          </p:cNvCxnSpPr>
          <p:nvPr/>
        </p:nvCxnSpPr>
        <p:spPr>
          <a:xfrm>
            <a:off x="8091883" y="1452990"/>
            <a:ext cx="0" cy="486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A53D5F97-214D-4C79-969C-CA77A804F306}"/>
              </a:ext>
            </a:extLst>
          </p:cNvPr>
          <p:cNvGrpSpPr/>
          <p:nvPr/>
        </p:nvGrpSpPr>
        <p:grpSpPr>
          <a:xfrm>
            <a:off x="217919" y="1290908"/>
            <a:ext cx="2997722" cy="2519056"/>
            <a:chOff x="6540136" y="1265238"/>
            <a:chExt cx="2997722" cy="2519056"/>
          </a:xfrm>
        </p:grpSpPr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FCA0F9B4-FF45-DA4C-93BD-B6361DE641F9}"/>
                </a:ext>
              </a:extLst>
            </p:cNvPr>
            <p:cNvSpPr txBox="1"/>
            <p:nvPr/>
          </p:nvSpPr>
          <p:spPr>
            <a:xfrm>
              <a:off x="6671828" y="1393200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FE6F0120-D835-754F-8089-8AFFCDC99597}"/>
                </a:ext>
              </a:extLst>
            </p:cNvPr>
            <p:cNvSpPr txBox="1"/>
            <p:nvPr/>
          </p:nvSpPr>
          <p:spPr>
            <a:xfrm>
              <a:off x="6671828" y="1934607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EDB574D6-A274-AB48-AB2A-5F7A67C1E0DF}"/>
                </a:ext>
              </a:extLst>
            </p:cNvPr>
            <p:cNvSpPr txBox="1"/>
            <p:nvPr/>
          </p:nvSpPr>
          <p:spPr>
            <a:xfrm>
              <a:off x="6734666" y="248222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76C2CD9A-113A-AE4E-B603-67931BB95C49}"/>
                </a:ext>
              </a:extLst>
            </p:cNvPr>
            <p:cNvSpPr txBox="1"/>
            <p:nvPr/>
          </p:nvSpPr>
          <p:spPr>
            <a:xfrm>
              <a:off x="6858684" y="302245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64411016-1D92-254C-A690-54C28F6DC240}"/>
                </a:ext>
              </a:extLst>
            </p:cNvPr>
            <p:cNvSpPr txBox="1"/>
            <p:nvPr/>
          </p:nvSpPr>
          <p:spPr>
            <a:xfrm>
              <a:off x="8008005" y="31549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F8448C4D-0BAB-464D-9624-D0900CA02624}"/>
                </a:ext>
              </a:extLst>
            </p:cNvPr>
            <p:cNvSpPr txBox="1"/>
            <p:nvPr/>
          </p:nvSpPr>
          <p:spPr>
            <a:xfrm>
              <a:off x="7814715" y="31557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120F1CFC-5D47-1044-9C23-2FCCFD27E78B}"/>
                </a:ext>
              </a:extLst>
            </p:cNvPr>
            <p:cNvSpPr txBox="1"/>
            <p:nvPr/>
          </p:nvSpPr>
          <p:spPr>
            <a:xfrm>
              <a:off x="7624868" y="31557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B38F1034-4AA3-4641-87CF-A66D6EAD46D3}"/>
                </a:ext>
              </a:extLst>
            </p:cNvPr>
            <p:cNvSpPr txBox="1"/>
            <p:nvPr/>
          </p:nvSpPr>
          <p:spPr>
            <a:xfrm>
              <a:off x="7432536" y="3155641"/>
              <a:ext cx="3473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5D9627DC-4D05-BB46-87F9-3AB39399E440}"/>
                </a:ext>
              </a:extLst>
            </p:cNvPr>
            <p:cNvSpPr txBox="1"/>
            <p:nvPr/>
          </p:nvSpPr>
          <p:spPr>
            <a:xfrm>
              <a:off x="7234802" y="315637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497252EC-F4AF-2244-88AB-879453D6D8BB}"/>
                </a:ext>
              </a:extLst>
            </p:cNvPr>
            <p:cNvSpPr txBox="1"/>
            <p:nvPr/>
          </p:nvSpPr>
          <p:spPr>
            <a:xfrm>
              <a:off x="6966084" y="3157162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873BA646-83FA-5D4C-B5A4-D3D4DEF407C0}"/>
                </a:ext>
              </a:extLst>
            </p:cNvPr>
            <p:cNvSpPr txBox="1"/>
            <p:nvPr/>
          </p:nvSpPr>
          <p:spPr>
            <a:xfrm>
              <a:off x="9153558" y="315603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296662EA-42A5-8F4B-9AEF-90D8176DE715}"/>
                </a:ext>
              </a:extLst>
            </p:cNvPr>
            <p:cNvSpPr txBox="1"/>
            <p:nvPr/>
          </p:nvSpPr>
          <p:spPr>
            <a:xfrm>
              <a:off x="8968326" y="31568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C9596BCB-9FF0-2649-ACE5-37763C9C4FA1}"/>
                </a:ext>
              </a:extLst>
            </p:cNvPr>
            <p:cNvSpPr txBox="1"/>
            <p:nvPr/>
          </p:nvSpPr>
          <p:spPr>
            <a:xfrm>
              <a:off x="8781163" y="31568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9AFCADB5-9C23-9A4A-B1CD-CC441DFC1225}"/>
                </a:ext>
              </a:extLst>
            </p:cNvPr>
            <p:cNvSpPr txBox="1"/>
            <p:nvPr/>
          </p:nvSpPr>
          <p:spPr>
            <a:xfrm>
              <a:off x="8588833" y="3156754"/>
              <a:ext cx="3473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0549661-7E3B-2546-B6F7-B40B22D8898B}"/>
                </a:ext>
              </a:extLst>
            </p:cNvPr>
            <p:cNvSpPr txBox="1"/>
            <p:nvPr/>
          </p:nvSpPr>
          <p:spPr>
            <a:xfrm>
              <a:off x="8396470" y="315474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14" name="Left Brace 213">
              <a:extLst>
                <a:ext uri="{FF2B5EF4-FFF2-40B4-BE49-F238E27FC236}">
                  <a16:creationId xmlns:a16="http://schemas.microsoft.com/office/drawing/2014/main" id="{D88B9678-2CE5-764A-A829-C8F0C6A93CB4}"/>
                </a:ext>
              </a:extLst>
            </p:cNvPr>
            <p:cNvSpPr/>
            <p:nvPr/>
          </p:nvSpPr>
          <p:spPr>
            <a:xfrm rot="16200000">
              <a:off x="7691396" y="2979159"/>
              <a:ext cx="175996" cy="864734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Left Brace 214">
              <a:extLst>
                <a:ext uri="{FF2B5EF4-FFF2-40B4-BE49-F238E27FC236}">
                  <a16:creationId xmlns:a16="http://schemas.microsoft.com/office/drawing/2014/main" id="{5CC4B30C-FD34-CC41-A4F6-AB6D87ADCBB7}"/>
                </a:ext>
              </a:extLst>
            </p:cNvPr>
            <p:cNvSpPr/>
            <p:nvPr/>
          </p:nvSpPr>
          <p:spPr>
            <a:xfrm rot="16200000">
              <a:off x="8845932" y="2980232"/>
              <a:ext cx="175996" cy="864734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38A80604-D8CD-9448-A20A-2BC12BF921E8}"/>
                </a:ext>
              </a:extLst>
            </p:cNvPr>
            <p:cNvSpPr txBox="1"/>
            <p:nvPr/>
          </p:nvSpPr>
          <p:spPr>
            <a:xfrm>
              <a:off x="8354639" y="3568850"/>
              <a:ext cx="11832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ELM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CFU/dose)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618962C2-E1C9-7E4E-AAEE-E2DD1D050195}"/>
                </a:ext>
              </a:extLst>
            </p:cNvPr>
            <p:cNvSpPr txBox="1"/>
            <p:nvPr/>
          </p:nvSpPr>
          <p:spPr>
            <a:xfrm>
              <a:off x="7197854" y="3565997"/>
              <a:ext cx="11832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ELM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CFU/dose)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E6C186FD-DC03-C647-84FC-EFA5A401C707}"/>
                </a:ext>
              </a:extLst>
            </p:cNvPr>
            <p:cNvSpPr txBox="1"/>
            <p:nvPr/>
          </p:nvSpPr>
          <p:spPr>
            <a:xfrm rot="16200000">
              <a:off x="6200940" y="2188375"/>
              <a:ext cx="9092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xin A (ng/g)</a:t>
              </a:r>
            </a:p>
          </p:txBody>
        </p:sp>
        <p:graphicFrame>
          <p:nvGraphicFramePr>
            <p:cNvPr id="219" name="Object 218">
              <a:extLst>
                <a:ext uri="{FF2B5EF4-FFF2-40B4-BE49-F238E27FC236}">
                  <a16:creationId xmlns:a16="http://schemas.microsoft.com/office/drawing/2014/main" id="{492EC458-15F2-2544-8839-6E9829845A0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16721187"/>
                </p:ext>
              </p:extLst>
            </p:nvPr>
          </p:nvGraphicFramePr>
          <p:xfrm>
            <a:off x="6983413" y="1265238"/>
            <a:ext cx="2493962" cy="20208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93" name="Prism 6" r:id="rId6" imgW="2972920" imgH="2233675" progId="Prism6.Document">
                    <p:embed/>
                  </p:oleObj>
                </mc:Choice>
                <mc:Fallback>
                  <p:oleObj name="Prism 6" r:id="rId6" imgW="2972920" imgH="2233675" progId="Prism6.Document">
                    <p:embed/>
                    <p:pic>
                      <p:nvPicPr>
                        <p:cNvPr id="201" name="Object 200">
                          <a:extLst>
                            <a:ext uri="{FF2B5EF4-FFF2-40B4-BE49-F238E27FC236}">
                              <a16:creationId xmlns:a16="http://schemas.microsoft.com/office/drawing/2014/main" id="{BB96CC67-91BD-4D2B-A3FD-A586EFB716E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983413" y="1265238"/>
                          <a:ext cx="2493962" cy="20208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20" name="Straight Connector 219">
              <a:extLst>
                <a:ext uri="{FF2B5EF4-FFF2-40B4-BE49-F238E27FC236}">
                  <a16:creationId xmlns:a16="http://schemas.microsoft.com/office/drawing/2014/main" id="{92D51386-E000-CB4B-A348-515F4E123C00}"/>
                </a:ext>
              </a:extLst>
            </p:cNvPr>
            <p:cNvCxnSpPr/>
            <p:nvPr/>
          </p:nvCxnSpPr>
          <p:spPr>
            <a:xfrm>
              <a:off x="7128991" y="2176214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220">
              <a:extLst>
                <a:ext uri="{FF2B5EF4-FFF2-40B4-BE49-F238E27FC236}">
                  <a16:creationId xmlns:a16="http://schemas.microsoft.com/office/drawing/2014/main" id="{FE231F3A-E44E-8247-AD07-82411DD82EC9}"/>
                </a:ext>
              </a:extLst>
            </p:cNvPr>
            <p:cNvCxnSpPr/>
            <p:nvPr/>
          </p:nvCxnSpPr>
          <p:spPr>
            <a:xfrm>
              <a:off x="7128991" y="2182417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21">
              <a:extLst>
                <a:ext uri="{FF2B5EF4-FFF2-40B4-BE49-F238E27FC236}">
                  <a16:creationId xmlns:a16="http://schemas.microsoft.com/office/drawing/2014/main" id="{766CF273-157D-D243-94E3-B66C42D73806}"/>
                </a:ext>
              </a:extLst>
            </p:cNvPr>
            <p:cNvCxnSpPr/>
            <p:nvPr/>
          </p:nvCxnSpPr>
          <p:spPr>
            <a:xfrm>
              <a:off x="7129610" y="2187066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Straight Connector 222">
              <a:extLst>
                <a:ext uri="{FF2B5EF4-FFF2-40B4-BE49-F238E27FC236}">
                  <a16:creationId xmlns:a16="http://schemas.microsoft.com/office/drawing/2014/main" id="{199E2B36-6A4E-2D42-918A-3841DBE101FE}"/>
                </a:ext>
              </a:extLst>
            </p:cNvPr>
            <p:cNvCxnSpPr/>
            <p:nvPr/>
          </p:nvCxnSpPr>
          <p:spPr>
            <a:xfrm>
              <a:off x="7184715" y="2176206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Straight Connector 223">
              <a:extLst>
                <a:ext uri="{FF2B5EF4-FFF2-40B4-BE49-F238E27FC236}">
                  <a16:creationId xmlns:a16="http://schemas.microsoft.com/office/drawing/2014/main" id="{0BC8A8D6-A930-3C47-AF36-23094952AC21}"/>
                </a:ext>
              </a:extLst>
            </p:cNvPr>
            <p:cNvCxnSpPr/>
            <p:nvPr/>
          </p:nvCxnSpPr>
          <p:spPr>
            <a:xfrm>
              <a:off x="7184715" y="2182409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915CDE2C-1670-1541-89B2-638CE918A215}"/>
                </a:ext>
              </a:extLst>
            </p:cNvPr>
            <p:cNvCxnSpPr/>
            <p:nvPr/>
          </p:nvCxnSpPr>
          <p:spPr>
            <a:xfrm>
              <a:off x="7185334" y="2187058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Straight Connector 225">
              <a:extLst>
                <a:ext uri="{FF2B5EF4-FFF2-40B4-BE49-F238E27FC236}">
                  <a16:creationId xmlns:a16="http://schemas.microsoft.com/office/drawing/2014/main" id="{220D78C7-F34A-3B44-956F-D84101AD2698}"/>
                </a:ext>
              </a:extLst>
            </p:cNvPr>
            <p:cNvCxnSpPr/>
            <p:nvPr/>
          </p:nvCxnSpPr>
          <p:spPr>
            <a:xfrm>
              <a:off x="7199242" y="2175924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Straight Connector 226">
              <a:extLst>
                <a:ext uri="{FF2B5EF4-FFF2-40B4-BE49-F238E27FC236}">
                  <a16:creationId xmlns:a16="http://schemas.microsoft.com/office/drawing/2014/main" id="{46B84EBA-6D60-A744-AD1B-F5454BDC162A}"/>
                </a:ext>
              </a:extLst>
            </p:cNvPr>
            <p:cNvCxnSpPr/>
            <p:nvPr/>
          </p:nvCxnSpPr>
          <p:spPr>
            <a:xfrm>
              <a:off x="7199241" y="2182127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Straight Connector 227">
              <a:extLst>
                <a:ext uri="{FF2B5EF4-FFF2-40B4-BE49-F238E27FC236}">
                  <a16:creationId xmlns:a16="http://schemas.microsoft.com/office/drawing/2014/main" id="{76F4C780-4A08-4F4B-8C66-6DE4BA0499C3}"/>
                </a:ext>
              </a:extLst>
            </p:cNvPr>
            <p:cNvCxnSpPr/>
            <p:nvPr/>
          </p:nvCxnSpPr>
          <p:spPr>
            <a:xfrm>
              <a:off x="7201408" y="2186775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Straight Connector 228">
              <a:extLst>
                <a:ext uri="{FF2B5EF4-FFF2-40B4-BE49-F238E27FC236}">
                  <a16:creationId xmlns:a16="http://schemas.microsoft.com/office/drawing/2014/main" id="{A0C60A76-9172-084C-B78F-A193C58A1556}"/>
                </a:ext>
              </a:extLst>
            </p:cNvPr>
            <p:cNvCxnSpPr/>
            <p:nvPr/>
          </p:nvCxnSpPr>
          <p:spPr>
            <a:xfrm>
              <a:off x="7129830" y="2171542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>
              <a:extLst>
                <a:ext uri="{FF2B5EF4-FFF2-40B4-BE49-F238E27FC236}">
                  <a16:creationId xmlns:a16="http://schemas.microsoft.com/office/drawing/2014/main" id="{F6069D1B-DB17-E348-A14A-5B4939FB991D}"/>
                </a:ext>
              </a:extLst>
            </p:cNvPr>
            <p:cNvCxnSpPr/>
            <p:nvPr/>
          </p:nvCxnSpPr>
          <p:spPr>
            <a:xfrm>
              <a:off x="7198311" y="2172758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Straight Connector 230">
              <a:extLst>
                <a:ext uri="{FF2B5EF4-FFF2-40B4-BE49-F238E27FC236}">
                  <a16:creationId xmlns:a16="http://schemas.microsoft.com/office/drawing/2014/main" id="{5547C0F6-DFC3-C140-ADE6-5C17DA1C3C61}"/>
                </a:ext>
              </a:extLst>
            </p:cNvPr>
            <p:cNvCxnSpPr/>
            <p:nvPr/>
          </p:nvCxnSpPr>
          <p:spPr>
            <a:xfrm>
              <a:off x="7178542" y="2171617"/>
              <a:ext cx="56259" cy="0"/>
            </a:xfrm>
            <a:prstGeom prst="line">
              <a:avLst/>
            </a:prstGeom>
            <a:ln>
              <a:solidFill>
                <a:srgbClr val="05694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321442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2097658-25F8-ED40-97B6-736FADA87EF2}"/>
              </a:ext>
            </a:extLst>
          </p:cNvPr>
          <p:cNvSpPr/>
          <p:nvPr/>
        </p:nvSpPr>
        <p:spPr>
          <a:xfrm>
            <a:off x="1164849" y="3946008"/>
            <a:ext cx="7641800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8: Effect of HELM</a:t>
            </a:r>
            <a:r>
              <a:rPr lang="en-GB" sz="1100" b="1" u="sng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 on colonization of </a:t>
            </a:r>
            <a:r>
              <a:rPr lang="en-GB" sz="11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C. difficile </a:t>
            </a:r>
            <a:r>
              <a:rPr lang="en-GB" sz="11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ribotypes</a:t>
            </a:r>
            <a:r>
              <a:rPr lang="en-GB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 027 and 078</a:t>
            </a:r>
          </a:p>
          <a:p>
            <a:pPr algn="just"/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A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ice (n=4/gp) were administered clindamycin (30 mg/kg) and 48h later challenged with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. difficil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ibotyp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078 (SH1) spores. Mic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dosed five-times (~2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FU/dose)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ith spores of either HEL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Bv277) or HEL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Bv378)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24h post challenge animals were culled, cecum removed, and ethanol resistant counts enumerated on ChromID medium (37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, 24h). </a:t>
            </a:r>
          </a:p>
          <a:p>
            <a:pPr algn="just"/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anel B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ice (n=4/gp) were administered clindamycin (30 mg/kg) and 48h later challenged with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. difficil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ibotyp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027 (R20291) spores. Mic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dosed five-times (~2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FU/dose)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ith spores of either HEL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Bv277) or HEL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Bv378)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24h post-challenge animals were culled, cecum removed, and ethanol resistant counts enumerated on ChromID medium (37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, 24h). </a:t>
            </a:r>
            <a:endParaRPr lang="en-GB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39F485-35AD-0440-AF96-EC98BEC0CC5F}"/>
              </a:ext>
            </a:extLst>
          </p:cNvPr>
          <p:cNvSpPr txBox="1"/>
          <p:nvPr/>
        </p:nvSpPr>
        <p:spPr>
          <a:xfrm>
            <a:off x="1277337" y="1055442"/>
            <a:ext cx="315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C0626B5D-2D27-864C-9745-38EC76DDBDA8}"/>
              </a:ext>
            </a:extLst>
          </p:cNvPr>
          <p:cNvGrpSpPr/>
          <p:nvPr/>
        </p:nvGrpSpPr>
        <p:grpSpPr>
          <a:xfrm>
            <a:off x="1434840" y="1410396"/>
            <a:ext cx="3085689" cy="2146599"/>
            <a:chOff x="1434840" y="1410396"/>
            <a:chExt cx="3085689" cy="2146599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9BD0D67D-79FA-1942-B458-98544E4F3C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54821708"/>
                </p:ext>
              </p:extLst>
            </p:nvPr>
          </p:nvGraphicFramePr>
          <p:xfrm>
            <a:off x="1839283" y="1410396"/>
            <a:ext cx="2681246" cy="20186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1" name="Prism 6" r:id="rId4" imgW="3468467" imgH="2611837" progId="Prism6.Document">
                    <p:embed/>
                  </p:oleObj>
                </mc:Choice>
                <mc:Fallback>
                  <p:oleObj name="Prism 6" r:id="rId4" imgW="3468467" imgH="2611837" progId="Prism6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CA5FD9E4-8838-4FBE-9753-0A8A10980B6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839283" y="1410396"/>
                          <a:ext cx="2681246" cy="20186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EE7FB64-0582-6D49-B8F9-324878C02F00}"/>
                </a:ext>
              </a:extLst>
            </p:cNvPr>
            <p:cNvSpPr txBox="1"/>
            <p:nvPr/>
          </p:nvSpPr>
          <p:spPr>
            <a:xfrm>
              <a:off x="2008705" y="3324316"/>
              <a:ext cx="7506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LM</a:t>
              </a:r>
              <a:r>
                <a:rPr lang="en-US" sz="900" baseline="300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sz="900" baseline="300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C96A7F5-86BF-8D4E-9239-3D0DB16C8696}"/>
                </a:ext>
              </a:extLst>
            </p:cNvPr>
            <p:cNvSpPr txBox="1"/>
            <p:nvPr/>
          </p:nvSpPr>
          <p:spPr>
            <a:xfrm>
              <a:off x="2837808" y="3326163"/>
              <a:ext cx="7506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LM</a:t>
              </a:r>
              <a:r>
                <a:rPr lang="en-US" sz="900" baseline="300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</a:t>
              </a:r>
              <a:endParaRPr lang="en-US" sz="900" i="1" baseline="300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5685ED-D8CF-0F4A-AAB0-DB11FAE2925B}"/>
                </a:ext>
              </a:extLst>
            </p:cNvPr>
            <p:cNvSpPr txBox="1"/>
            <p:nvPr/>
          </p:nvSpPr>
          <p:spPr>
            <a:xfrm rot="16200000">
              <a:off x="951374" y="2354055"/>
              <a:ext cx="1197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78 spores (CFU/g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CB95C1-321F-D34B-A538-34FE4F4ABFCB}"/>
                </a:ext>
              </a:extLst>
            </p:cNvPr>
            <p:cNvSpPr txBox="1"/>
            <p:nvPr/>
          </p:nvSpPr>
          <p:spPr>
            <a:xfrm>
              <a:off x="3807356" y="3326026"/>
              <a:ext cx="5502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F083525-374B-3A4B-8946-F31AF040002F}"/>
                </a:ext>
              </a:extLst>
            </p:cNvPr>
            <p:cNvSpPr txBox="1"/>
            <p:nvPr/>
          </p:nvSpPr>
          <p:spPr>
            <a:xfrm>
              <a:off x="1590602" y="2527537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21DDC29-32B9-8F47-95A7-C8EF3F7DDB4F}"/>
                </a:ext>
              </a:extLst>
            </p:cNvPr>
            <p:cNvSpPr txBox="1"/>
            <p:nvPr/>
          </p:nvSpPr>
          <p:spPr>
            <a:xfrm>
              <a:off x="1590602" y="2848554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46D5A48-9901-E541-A3DC-1081E0D6B0FA}"/>
                </a:ext>
              </a:extLst>
            </p:cNvPr>
            <p:cNvSpPr txBox="1"/>
            <p:nvPr/>
          </p:nvSpPr>
          <p:spPr>
            <a:xfrm>
              <a:off x="1595413" y="1526488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68D1060-C495-5845-9FD6-A6984FD0D461}"/>
                </a:ext>
              </a:extLst>
            </p:cNvPr>
            <p:cNvSpPr txBox="1"/>
            <p:nvPr/>
          </p:nvSpPr>
          <p:spPr>
            <a:xfrm>
              <a:off x="1592914" y="1857041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1698066-8BC7-374A-B0B3-18E124CE471E}"/>
                </a:ext>
              </a:extLst>
            </p:cNvPr>
            <p:cNvSpPr txBox="1"/>
            <p:nvPr/>
          </p:nvSpPr>
          <p:spPr>
            <a:xfrm>
              <a:off x="1592914" y="2183878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81F0F7C-6E3F-A24B-B3EE-4515DAE316CB}"/>
                </a:ext>
              </a:extLst>
            </p:cNvPr>
            <p:cNvSpPr txBox="1"/>
            <p:nvPr/>
          </p:nvSpPr>
          <p:spPr>
            <a:xfrm>
              <a:off x="1590602" y="3177953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DC3F4CC-5909-384D-BD63-A01C20ECD8E6}"/>
              </a:ext>
            </a:extLst>
          </p:cNvPr>
          <p:cNvGrpSpPr/>
          <p:nvPr/>
        </p:nvGrpSpPr>
        <p:grpSpPr>
          <a:xfrm>
            <a:off x="5424838" y="1359439"/>
            <a:ext cx="3105381" cy="2195709"/>
            <a:chOff x="5901041" y="1364473"/>
            <a:chExt cx="3105381" cy="2195709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E2F03BA0-87E7-A745-A121-681E7DCEDD5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59647606"/>
                </p:ext>
              </p:extLst>
            </p:nvPr>
          </p:nvGraphicFramePr>
          <p:xfrm>
            <a:off x="6315066" y="1364473"/>
            <a:ext cx="2691356" cy="20752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2" name="Prism 6" r:id="rId6" imgW="3468467" imgH="2611837" progId="Prism6.Document">
                    <p:embed/>
                  </p:oleObj>
                </mc:Choice>
                <mc:Fallback>
                  <p:oleObj name="Prism 6" r:id="rId6" imgW="3468467" imgH="2611837" progId="Prism6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161CBA14-E989-4A15-8474-E68367D59C9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315066" y="1364473"/>
                          <a:ext cx="2691356" cy="20752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20EA105-AB4E-5E4E-98FE-589D5279D710}"/>
                </a:ext>
              </a:extLst>
            </p:cNvPr>
            <p:cNvSpPr txBox="1"/>
            <p:nvPr/>
          </p:nvSpPr>
          <p:spPr>
            <a:xfrm>
              <a:off x="6474906" y="3327502"/>
              <a:ext cx="7506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LM</a:t>
              </a:r>
              <a:r>
                <a:rPr lang="en-US" sz="900" baseline="300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sz="900" baseline="300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EE8027F-E594-CC4C-B6B9-ED06E7DCC736}"/>
                </a:ext>
              </a:extLst>
            </p:cNvPr>
            <p:cNvSpPr txBox="1"/>
            <p:nvPr/>
          </p:nvSpPr>
          <p:spPr>
            <a:xfrm>
              <a:off x="7304009" y="3329350"/>
              <a:ext cx="7506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LM</a:t>
              </a:r>
              <a:r>
                <a:rPr lang="en-US" sz="900" baseline="300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</a:t>
              </a:r>
              <a:endParaRPr lang="en-US" sz="900" i="1" baseline="300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ECCFBD9-5D93-C548-BCBB-BD31E8C13BBF}"/>
                </a:ext>
              </a:extLst>
            </p:cNvPr>
            <p:cNvSpPr txBox="1"/>
            <p:nvPr/>
          </p:nvSpPr>
          <p:spPr>
            <a:xfrm rot="16200000">
              <a:off x="5417575" y="2357242"/>
              <a:ext cx="1197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27 spores (CFU/g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638D38D-5AE3-9440-B481-36FA7D54B6B9}"/>
                </a:ext>
              </a:extLst>
            </p:cNvPr>
            <p:cNvSpPr txBox="1"/>
            <p:nvPr/>
          </p:nvSpPr>
          <p:spPr>
            <a:xfrm>
              <a:off x="8273558" y="3329213"/>
              <a:ext cx="5502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C16554A-8EDA-594D-80F3-B5EEA49C9370}"/>
                </a:ext>
              </a:extLst>
            </p:cNvPr>
            <p:cNvSpPr txBox="1"/>
            <p:nvPr/>
          </p:nvSpPr>
          <p:spPr>
            <a:xfrm>
              <a:off x="6056803" y="2519099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666AE59-AB00-154C-AB6F-CD4DE38B945A}"/>
                </a:ext>
              </a:extLst>
            </p:cNvPr>
            <p:cNvSpPr txBox="1"/>
            <p:nvPr/>
          </p:nvSpPr>
          <p:spPr>
            <a:xfrm>
              <a:off x="6056803" y="2863366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BE59A74-E907-1C4C-B4A7-021EFF6E4518}"/>
                </a:ext>
              </a:extLst>
            </p:cNvPr>
            <p:cNvSpPr txBox="1"/>
            <p:nvPr/>
          </p:nvSpPr>
          <p:spPr>
            <a:xfrm>
              <a:off x="6061614" y="1494801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67B1C4D-681F-5644-A4C0-4FA507C751CF}"/>
                </a:ext>
              </a:extLst>
            </p:cNvPr>
            <p:cNvSpPr txBox="1"/>
            <p:nvPr/>
          </p:nvSpPr>
          <p:spPr>
            <a:xfrm>
              <a:off x="6059115" y="1833103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94BADEA-3F67-8B41-A25A-8819D71A80E7}"/>
                </a:ext>
              </a:extLst>
            </p:cNvPr>
            <p:cNvSpPr txBox="1"/>
            <p:nvPr/>
          </p:nvSpPr>
          <p:spPr>
            <a:xfrm>
              <a:off x="6059115" y="2187065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3ED5801-3D23-0946-88D5-FAB439795B05}"/>
                </a:ext>
              </a:extLst>
            </p:cNvPr>
            <p:cNvSpPr txBox="1"/>
            <p:nvPr/>
          </p:nvSpPr>
          <p:spPr>
            <a:xfrm>
              <a:off x="6056803" y="3200515"/>
              <a:ext cx="373063" cy="246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5DB2EE60-31A3-004A-8804-56EA262ADAD6}"/>
              </a:ext>
            </a:extLst>
          </p:cNvPr>
          <p:cNvSpPr txBox="1"/>
          <p:nvPr/>
        </p:nvSpPr>
        <p:spPr>
          <a:xfrm>
            <a:off x="5148422" y="1055442"/>
            <a:ext cx="315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368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C78ACB57010B40A063B2A896AD669C" ma:contentTypeVersion="13" ma:contentTypeDescription="Create a new document." ma:contentTypeScope="" ma:versionID="20476ded08c9fee0a206932a6f077957">
  <xsd:schema xmlns:xsd="http://www.w3.org/2001/XMLSchema" xmlns:xs="http://www.w3.org/2001/XMLSchema" xmlns:p="http://schemas.microsoft.com/office/2006/metadata/properties" xmlns:ns3="f3346a12-1b78-440e-9162-a92baa7f0adb" xmlns:ns4="b8c33dc1-f11f-4920-a897-e4bd0456cb87" targetNamespace="http://schemas.microsoft.com/office/2006/metadata/properties" ma:root="true" ma:fieldsID="53f2be035b175df5b71173bff1712aea" ns3:_="" ns4:_="">
    <xsd:import namespace="f3346a12-1b78-440e-9162-a92baa7f0adb"/>
    <xsd:import namespace="b8c33dc1-f11f-4920-a897-e4bd0456cb8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OCR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346a12-1b78-440e-9162-a92baa7f0ad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8c33dc1-f11f-4920-a897-e4bd0456cb87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2E0706B-EF16-4F49-A781-113B7BBB607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7878DD5-F767-4C27-8E7C-97EFF1386AB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3346a12-1b78-440e-9162-a92baa7f0adb"/>
    <ds:schemaRef ds:uri="b8c33dc1-f11f-4920-a897-e4bd0456cb8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CFD9063-68C4-4D89-86F5-74C0D505373D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b8c33dc1-f11f-4920-a897-e4bd0456cb87"/>
    <ds:schemaRef ds:uri="f3346a12-1b78-440e-9162-a92baa7f0adb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7</TotalTime>
  <Words>1579</Words>
  <Application>Microsoft Office PowerPoint</Application>
  <PresentationFormat>A4 Paper (210x297 mm)</PresentationFormat>
  <Paragraphs>147</Paragraphs>
  <Slides>8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Cutting</dc:creator>
  <cp:lastModifiedBy>William Ferreira</cp:lastModifiedBy>
  <cp:revision>97</cp:revision>
  <cp:lastPrinted>2021-12-19T09:06:46Z</cp:lastPrinted>
  <dcterms:created xsi:type="dcterms:W3CDTF">2021-05-19T08:01:05Z</dcterms:created>
  <dcterms:modified xsi:type="dcterms:W3CDTF">2022-04-18T18:16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C78ACB57010B40A063B2A896AD669C</vt:lpwstr>
  </property>
</Properties>
</file>